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71" r:id="rId2"/>
    <p:sldId id="272" r:id="rId3"/>
  </p:sldIdLst>
  <p:sldSz cx="6300788" cy="82073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7"/>
    <p:restoredTop sz="94640"/>
  </p:normalViewPr>
  <p:slideViewPr>
    <p:cSldViewPr snapToGrid="0">
      <p:cViewPr>
        <p:scale>
          <a:sx n="180" d="100"/>
          <a:sy n="180" d="100"/>
        </p:scale>
        <p:origin x="178" y="-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4332DF-8B39-6949-8F60-C044267D74D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1143000"/>
            <a:ext cx="2368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BA4506-9A21-5A4F-9115-003294445DE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447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4725" y="1143000"/>
            <a:ext cx="23685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E7D2CC-C2F8-A64D-93E3-F2E64EE5B16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4014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4E3A4DB-8CC2-5AD9-BEE0-6ECB7E8427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6FCC284-5BEC-BC9E-C293-3695FFC7AA0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44725" y="1143000"/>
            <a:ext cx="236855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A914A35A-22BA-E358-57DB-F5341143607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DC429B-97BA-D099-C6EE-A2C06DF1E69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E7D2CC-C2F8-A64D-93E3-F2E64EE5B16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0084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559" y="1343199"/>
            <a:ext cx="5355670" cy="2857382"/>
          </a:xfrm>
        </p:spPr>
        <p:txBody>
          <a:bodyPr anchor="b"/>
          <a:lstStyle>
            <a:lvl1pPr algn="ctr">
              <a:defRPr sz="413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4310772"/>
            <a:ext cx="4725591" cy="1981549"/>
          </a:xfrm>
        </p:spPr>
        <p:txBody>
          <a:bodyPr/>
          <a:lstStyle>
            <a:lvl1pPr marL="0" indent="0" algn="ctr">
              <a:buNone/>
              <a:defRPr sz="1654"/>
            </a:lvl1pPr>
            <a:lvl2pPr marL="315057" indent="0" algn="ctr">
              <a:buNone/>
              <a:defRPr sz="1378"/>
            </a:lvl2pPr>
            <a:lvl3pPr marL="630113" indent="0" algn="ctr">
              <a:buNone/>
              <a:defRPr sz="1240"/>
            </a:lvl3pPr>
            <a:lvl4pPr marL="945170" indent="0" algn="ctr">
              <a:buNone/>
              <a:defRPr sz="1103"/>
            </a:lvl4pPr>
            <a:lvl5pPr marL="1260226" indent="0" algn="ctr">
              <a:buNone/>
              <a:defRPr sz="1103"/>
            </a:lvl5pPr>
            <a:lvl6pPr marL="1575283" indent="0" algn="ctr">
              <a:buNone/>
              <a:defRPr sz="1103"/>
            </a:lvl6pPr>
            <a:lvl7pPr marL="1890339" indent="0" algn="ctr">
              <a:buNone/>
              <a:defRPr sz="1103"/>
            </a:lvl7pPr>
            <a:lvl8pPr marL="2205396" indent="0" algn="ctr">
              <a:buNone/>
              <a:defRPr sz="1103"/>
            </a:lvl8pPr>
            <a:lvl9pPr marL="2520452" indent="0" algn="ctr">
              <a:buNone/>
              <a:defRPr sz="110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611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03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436967"/>
            <a:ext cx="1358607" cy="6955371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80" y="436967"/>
            <a:ext cx="3997062" cy="6955371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954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124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8" y="2046147"/>
            <a:ext cx="5434430" cy="3414039"/>
          </a:xfrm>
        </p:spPr>
        <p:txBody>
          <a:bodyPr anchor="b"/>
          <a:lstStyle>
            <a:lvl1pPr>
              <a:defRPr sz="413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8" y="5492484"/>
            <a:ext cx="5434430" cy="1795363"/>
          </a:xfrm>
        </p:spPr>
        <p:txBody>
          <a:bodyPr/>
          <a:lstStyle>
            <a:lvl1pPr marL="0" indent="0">
              <a:buNone/>
              <a:defRPr sz="1654">
                <a:solidFill>
                  <a:schemeClr val="tx1">
                    <a:tint val="82000"/>
                  </a:schemeClr>
                </a:solidFill>
              </a:defRPr>
            </a:lvl1pPr>
            <a:lvl2pPr marL="315057" indent="0">
              <a:buNone/>
              <a:defRPr sz="1378">
                <a:solidFill>
                  <a:schemeClr val="tx1">
                    <a:tint val="82000"/>
                  </a:schemeClr>
                </a:solidFill>
              </a:defRPr>
            </a:lvl2pPr>
            <a:lvl3pPr marL="630113" indent="0">
              <a:buNone/>
              <a:defRPr sz="1240">
                <a:solidFill>
                  <a:schemeClr val="tx1">
                    <a:tint val="82000"/>
                  </a:schemeClr>
                </a:solidFill>
              </a:defRPr>
            </a:lvl3pPr>
            <a:lvl4pPr marL="945170" indent="0">
              <a:buNone/>
              <a:defRPr sz="1103">
                <a:solidFill>
                  <a:schemeClr val="tx1">
                    <a:tint val="82000"/>
                  </a:schemeClr>
                </a:solidFill>
              </a:defRPr>
            </a:lvl4pPr>
            <a:lvl5pPr marL="1260226" indent="0">
              <a:buNone/>
              <a:defRPr sz="1103">
                <a:solidFill>
                  <a:schemeClr val="tx1">
                    <a:tint val="82000"/>
                  </a:schemeClr>
                </a:solidFill>
              </a:defRPr>
            </a:lvl5pPr>
            <a:lvl6pPr marL="1575283" indent="0">
              <a:buNone/>
              <a:defRPr sz="1103">
                <a:solidFill>
                  <a:schemeClr val="tx1">
                    <a:tint val="82000"/>
                  </a:schemeClr>
                </a:solidFill>
              </a:defRPr>
            </a:lvl6pPr>
            <a:lvl7pPr marL="1890339" indent="0">
              <a:buNone/>
              <a:defRPr sz="1103">
                <a:solidFill>
                  <a:schemeClr val="tx1">
                    <a:tint val="82000"/>
                  </a:schemeClr>
                </a:solidFill>
              </a:defRPr>
            </a:lvl7pPr>
            <a:lvl8pPr marL="2205396" indent="0">
              <a:buNone/>
              <a:defRPr sz="1103">
                <a:solidFill>
                  <a:schemeClr val="tx1">
                    <a:tint val="82000"/>
                  </a:schemeClr>
                </a:solidFill>
              </a:defRPr>
            </a:lvl8pPr>
            <a:lvl9pPr marL="2520452" indent="0">
              <a:buNone/>
              <a:defRPr sz="110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402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2184834"/>
            <a:ext cx="2677835" cy="52075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2184834"/>
            <a:ext cx="2677835" cy="52075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250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436968"/>
            <a:ext cx="5434430" cy="158638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1" y="2011948"/>
            <a:ext cx="2665528" cy="986024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1" y="2997972"/>
            <a:ext cx="2665528" cy="440956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2011948"/>
            <a:ext cx="2678656" cy="986024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2997972"/>
            <a:ext cx="2678656" cy="440956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780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044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527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47158"/>
            <a:ext cx="2032168" cy="1915054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1181712"/>
            <a:ext cx="3189774" cy="5832556"/>
          </a:xfrm>
        </p:spPr>
        <p:txBody>
          <a:bodyPr/>
          <a:lstStyle>
            <a:lvl1pPr>
              <a:defRPr sz="2205"/>
            </a:lvl1pPr>
            <a:lvl2pPr>
              <a:defRPr sz="1929"/>
            </a:lvl2pPr>
            <a:lvl3pPr>
              <a:defRPr sz="1654"/>
            </a:lvl3pPr>
            <a:lvl4pPr>
              <a:defRPr sz="1378"/>
            </a:lvl4pPr>
            <a:lvl5pPr>
              <a:defRPr sz="1378"/>
            </a:lvl5pPr>
            <a:lvl6pPr>
              <a:defRPr sz="1378"/>
            </a:lvl6pPr>
            <a:lvl7pPr>
              <a:defRPr sz="1378"/>
            </a:lvl7pPr>
            <a:lvl8pPr>
              <a:defRPr sz="1378"/>
            </a:lvl8pPr>
            <a:lvl9pPr>
              <a:defRPr sz="1378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462213"/>
            <a:ext cx="2032168" cy="4561553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850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47158"/>
            <a:ext cx="2032168" cy="1915054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1181712"/>
            <a:ext cx="3189774" cy="5832556"/>
          </a:xfrm>
        </p:spPr>
        <p:txBody>
          <a:bodyPr anchor="t"/>
          <a:lstStyle>
            <a:lvl1pPr marL="0" indent="0">
              <a:buNone/>
              <a:defRPr sz="2205"/>
            </a:lvl1pPr>
            <a:lvl2pPr marL="315057" indent="0">
              <a:buNone/>
              <a:defRPr sz="1929"/>
            </a:lvl2pPr>
            <a:lvl3pPr marL="630113" indent="0">
              <a:buNone/>
              <a:defRPr sz="1654"/>
            </a:lvl3pPr>
            <a:lvl4pPr marL="945170" indent="0">
              <a:buNone/>
              <a:defRPr sz="1378"/>
            </a:lvl4pPr>
            <a:lvl5pPr marL="1260226" indent="0">
              <a:buNone/>
              <a:defRPr sz="1378"/>
            </a:lvl5pPr>
            <a:lvl6pPr marL="1575283" indent="0">
              <a:buNone/>
              <a:defRPr sz="1378"/>
            </a:lvl6pPr>
            <a:lvl7pPr marL="1890339" indent="0">
              <a:buNone/>
              <a:defRPr sz="1378"/>
            </a:lvl7pPr>
            <a:lvl8pPr marL="2205396" indent="0">
              <a:buNone/>
              <a:defRPr sz="1378"/>
            </a:lvl8pPr>
            <a:lvl9pPr marL="2520452" indent="0">
              <a:buNone/>
              <a:defRPr sz="1378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462213"/>
            <a:ext cx="2032168" cy="4561553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478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436968"/>
            <a:ext cx="5434430" cy="15863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2184834"/>
            <a:ext cx="5434430" cy="5207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7607022"/>
            <a:ext cx="1417677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132F2F-C6DB-7E49-940E-2B929CA0AD34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7607022"/>
            <a:ext cx="2126516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7607022"/>
            <a:ext cx="1417677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556D7E6-DEBB-B44F-97A5-6EB9C47AD05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396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30113" rtl="0" eaLnBrk="1" latinLnBrk="0" hangingPunct="1">
        <a:lnSpc>
          <a:spcPct val="90000"/>
        </a:lnSpc>
        <a:spcBef>
          <a:spcPct val="0"/>
        </a:spcBef>
        <a:buNone/>
        <a:defRPr sz="303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28" indent="-157528" algn="l" defTabSz="63011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1pPr>
      <a:lvl2pPr marL="472585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78764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3pPr>
      <a:lvl4pPr marL="1102698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41775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73281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2047867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36292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677980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1pPr>
      <a:lvl2pPr marL="315057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63011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4517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26022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57528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1890339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20539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520452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BFF308-7048-241B-8BE7-ECA48D233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00020" y="166396"/>
            <a:ext cx="4900750" cy="388279"/>
          </a:xfrm>
        </p:spPr>
        <p:txBody>
          <a:bodyPr>
            <a:normAutofit fontScale="90000"/>
          </a:bodyPr>
          <a:lstStyle/>
          <a:p>
            <a:r>
              <a:rPr lang="en-US" sz="149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49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491" dirty="0">
                <a:latin typeface="Arial" panose="020B0604020202020204" pitchFamily="34" charset="0"/>
                <a:cs typeface="Arial" panose="020B0604020202020204" pitchFamily="34" charset="0"/>
              </a:rPr>
              <a:t>2 . Calcium is required for CXCL-1-induced CD11a activity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70C61D-861C-6E7A-03EA-AABAD3A937FA}"/>
              </a:ext>
            </a:extLst>
          </p:cNvPr>
          <p:cNvSpPr txBox="1"/>
          <p:nvPr/>
        </p:nvSpPr>
        <p:spPr>
          <a:xfrm>
            <a:off x="354931" y="577096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B0C14E-7B73-9C63-E3AA-652E754CDBCD}"/>
              </a:ext>
            </a:extLst>
          </p:cNvPr>
          <p:cNvSpPr txBox="1"/>
          <p:nvPr/>
        </p:nvSpPr>
        <p:spPr>
          <a:xfrm>
            <a:off x="1670648" y="577096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12DDE2B-779D-E473-F8EE-BE339A5F6B9B}"/>
              </a:ext>
            </a:extLst>
          </p:cNvPr>
          <p:cNvSpPr txBox="1"/>
          <p:nvPr/>
        </p:nvSpPr>
        <p:spPr>
          <a:xfrm>
            <a:off x="354931" y="1982087"/>
            <a:ext cx="28405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CA89B92-21D5-03D0-C123-86DE23FE1E66}"/>
              </a:ext>
            </a:extLst>
          </p:cNvPr>
          <p:cNvSpPr txBox="1"/>
          <p:nvPr/>
        </p:nvSpPr>
        <p:spPr>
          <a:xfrm>
            <a:off x="1670648" y="1982087"/>
            <a:ext cx="27603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914EE71-DED0-0ECE-368B-599A7AE79B92}"/>
              </a:ext>
            </a:extLst>
          </p:cNvPr>
          <p:cNvSpPr txBox="1"/>
          <p:nvPr/>
        </p:nvSpPr>
        <p:spPr>
          <a:xfrm>
            <a:off x="3145375" y="1982087"/>
            <a:ext cx="30008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AF3E1FF-FD81-2544-0992-83E8CB120E14}"/>
              </a:ext>
            </a:extLst>
          </p:cNvPr>
          <p:cNvSpPr txBox="1"/>
          <p:nvPr/>
        </p:nvSpPr>
        <p:spPr>
          <a:xfrm>
            <a:off x="4397202" y="1982087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68FBB8-1C4B-1C11-9701-A3EFCEE4940F}"/>
              </a:ext>
            </a:extLst>
          </p:cNvPr>
          <p:cNvSpPr txBox="1"/>
          <p:nvPr/>
        </p:nvSpPr>
        <p:spPr>
          <a:xfrm>
            <a:off x="3033210" y="577096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3F4039-ECD1-558F-38E4-DC2D3D8F4AEA}"/>
              </a:ext>
            </a:extLst>
          </p:cNvPr>
          <p:cNvSpPr txBox="1"/>
          <p:nvPr/>
        </p:nvSpPr>
        <p:spPr>
          <a:xfrm>
            <a:off x="4731955" y="577096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328149-AD6E-5890-203F-B8741DD9EB11}"/>
              </a:ext>
            </a:extLst>
          </p:cNvPr>
          <p:cNvSpPr txBox="1"/>
          <p:nvPr/>
        </p:nvSpPr>
        <p:spPr>
          <a:xfrm>
            <a:off x="371508" y="3445725"/>
            <a:ext cx="226344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6" name="Picture 5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447075A1-22BA-2AA4-12B9-E4F523C6AD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6029" y="777301"/>
            <a:ext cx="1532079" cy="1140601"/>
          </a:xfrm>
          <a:prstGeom prst="rect">
            <a:avLst/>
          </a:prstGeom>
        </p:spPr>
      </p:pic>
      <p:pic>
        <p:nvPicPr>
          <p:cNvPr id="25" name="Picture 24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D33C5C56-758B-0250-046F-01F8271E32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22654" y="2110635"/>
            <a:ext cx="1393175" cy="1137499"/>
          </a:xfrm>
          <a:prstGeom prst="rect">
            <a:avLst/>
          </a:prstGeom>
        </p:spPr>
      </p:pic>
      <p:pic>
        <p:nvPicPr>
          <p:cNvPr id="27" name="Picture 26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5E569643-DD9D-E948-4FF1-E31E8EDB0C4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12520" y="801258"/>
            <a:ext cx="1440137" cy="1069666"/>
          </a:xfrm>
          <a:prstGeom prst="rect">
            <a:avLst/>
          </a:prstGeom>
        </p:spPr>
      </p:pic>
      <p:pic>
        <p:nvPicPr>
          <p:cNvPr id="29" name="Picture 28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10A1CB14-104E-642A-1A5D-5CCB96F2BAD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1508" y="3527111"/>
            <a:ext cx="1513186" cy="1153152"/>
          </a:xfrm>
          <a:prstGeom prst="rect">
            <a:avLst/>
          </a:prstGeom>
        </p:spPr>
      </p:pic>
      <p:pic>
        <p:nvPicPr>
          <p:cNvPr id="31" name="Picture 30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6E28692C-B34A-EAB1-E778-1654BBB440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89534" y="1870924"/>
            <a:ext cx="1288817" cy="1410581"/>
          </a:xfrm>
          <a:prstGeom prst="rect">
            <a:avLst/>
          </a:prstGeom>
        </p:spPr>
      </p:pic>
      <p:pic>
        <p:nvPicPr>
          <p:cNvPr id="33" name="Picture 32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B60B0192-9792-A609-13DA-80214F47348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16682" y="887857"/>
            <a:ext cx="1393175" cy="983067"/>
          </a:xfrm>
          <a:prstGeom prst="rect">
            <a:avLst/>
          </a:prstGeom>
        </p:spPr>
      </p:pic>
      <p:pic>
        <p:nvPicPr>
          <p:cNvPr id="35" name="Picture 34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B55917B9-62E5-C9CF-8BFB-2ADE839C3FA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45375" y="2095086"/>
            <a:ext cx="1492315" cy="1143266"/>
          </a:xfrm>
          <a:prstGeom prst="rect">
            <a:avLst/>
          </a:prstGeom>
        </p:spPr>
      </p:pic>
      <p:pic>
        <p:nvPicPr>
          <p:cNvPr id="37" name="Picture 36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18A26F3F-6EBB-839A-FD76-58270C50ED3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4218" y="2124996"/>
            <a:ext cx="999762" cy="1424662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2D815083-5A2C-1728-A362-221C58185E8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63882" y="732384"/>
            <a:ext cx="962271" cy="12497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0406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8A36BE0-BD21-720A-6B41-82A17E903B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AE293A5-8C82-4BE3-26E8-C819751CB6C3}"/>
              </a:ext>
            </a:extLst>
          </p:cNvPr>
          <p:cNvSpPr txBox="1"/>
          <p:nvPr/>
        </p:nvSpPr>
        <p:spPr>
          <a:xfrm>
            <a:off x="511925" y="816441"/>
            <a:ext cx="5088845" cy="40463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Supplemental Fig. 2. Calcium is required CXCL-1-induced CD11a activation.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A, B, C, F, G, H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Binding of fluorescently coupled β</a:t>
            </a:r>
            <a:r>
              <a:rPr lang="en-US" sz="1000" baseline="-25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-integrin ligands in unstimulated or CXCL-1 stimulated neutrophils. ICAM-1 binding to control neutrophils in presence of IgG or blocking anti-CD11a or anti-CD11b antibodies was assessed by flow cytometry, n=3, experimental repeat. In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control and Rap1a-KO = Rap1a</a:t>
            </a:r>
            <a:r>
              <a:rPr lang="en-US" sz="1000" baseline="30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neutrophils binding of fluorescently coupled β</a:t>
            </a:r>
            <a:r>
              <a:rPr lang="en-US" sz="1000" baseline="-25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-integrin ligands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ICAM-1 and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fibrinogen was assessed by flow cytometry, n=3-4, experimental repeat. I</a:t>
            </a:r>
            <a:r>
              <a:rPr lang="de-DE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ntracellular</a:t>
            </a:r>
            <a:r>
              <a:rPr lang="de-DE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de-DE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alcium</a:t>
            </a:r>
            <a:r>
              <a:rPr lang="de-DE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de-DE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levels</a:t>
            </a:r>
            <a:r>
              <a:rPr lang="de-DE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de-DE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were</a:t>
            </a:r>
            <a:r>
              <a:rPr lang="de-DE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analyzed</a:t>
            </a:r>
            <a:r>
              <a:rPr lang="de-DE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in Fluo-4 </a:t>
            </a:r>
            <a:r>
              <a:rPr lang="de-DE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labeled</a:t>
            </a:r>
            <a:r>
              <a:rPr lang="de-DE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ontrol neutrophils, incubated with either DMSO (control),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D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BAPTA or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E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thapsigargin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de-DE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before</a:t>
            </a:r>
            <a:r>
              <a:rPr lang="de-DE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de-DE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and</a:t>
            </a:r>
            <a:r>
              <a:rPr lang="de-DE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after CXCL-1 </a:t>
            </a:r>
            <a:r>
              <a:rPr lang="de-DE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stimulation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. Binding of fluorescent coupled β</a:t>
            </a:r>
            <a:r>
              <a:rPr lang="en-US" sz="1000" baseline="-25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-integrin ligands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F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G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ICAM-1 and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H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I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fibrinogen to control neutrophils, incubated with either DMSO (control),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F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H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BAPTA or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I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)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thapsigargin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was assessed by flow cytometry, n=3-5, experimental repeat. Data are mean </a:t>
            </a:r>
            <a:r>
              <a:rPr lang="en-GB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±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SEM. *p&lt;0.05, **p&lt;0.01, ***p&lt;0.001, ****p&lt;0.0001, ns=non significant by one-way ANOVA.</a:t>
            </a:r>
            <a:endParaRPr lang="de-DE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6418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9</Words>
  <Application>Microsoft Office PowerPoint</Application>
  <PresentationFormat>Benutzerdefiniert</PresentationFormat>
  <Paragraphs>13</Paragraphs>
  <Slides>2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imes New Roman</vt:lpstr>
      <vt:lpstr>Office Theme</vt:lpstr>
      <vt:lpstr>Supplemental Fig. 2 . Calcium is required for CXCL-1-induced CD11a activity.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2 . Calcium is required for CXCL-1-induced CD11a activity.</dc:title>
  <dc:creator>Marina Oguama</dc:creator>
  <cp:lastModifiedBy>Cappenberg</cp:lastModifiedBy>
  <cp:revision>22</cp:revision>
  <dcterms:created xsi:type="dcterms:W3CDTF">2025-08-04T09:00:18Z</dcterms:created>
  <dcterms:modified xsi:type="dcterms:W3CDTF">2025-12-23T07:33:30Z</dcterms:modified>
</cp:coreProperties>
</file>